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sldIdLst>
    <p:sldId id="256" r:id="rId2"/>
  </p:sldIdLst>
  <p:sldSz cx="7620000" cy="19050000"/>
  <p:notesSz cx="6858000" cy="9144000"/>
  <p:embeddedFontLst>
    <p:embeddedFont>
      <p:font typeface="Arial Bold" panose="020B0604020202020204" charset="0"/>
      <p:regular r:id="rId3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22" autoAdjust="0"/>
  </p:normalViewPr>
  <p:slideViewPr>
    <p:cSldViewPr>
      <p:cViewPr>
        <p:scale>
          <a:sx n="30" d="100"/>
          <a:sy n="30" d="100"/>
        </p:scale>
        <p:origin x="2909" y="1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font" Target="fonts/font1.fntdata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6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CFC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2" name="Grupo 101">
            <a:extLst>
              <a:ext uri="{FF2B5EF4-FFF2-40B4-BE49-F238E27FC236}">
                <a16:creationId xmlns:a16="http://schemas.microsoft.com/office/drawing/2014/main" id="{39D9F6C7-33A0-E1A4-975B-FC3F5C181456}"/>
              </a:ext>
            </a:extLst>
          </p:cNvPr>
          <p:cNvGrpSpPr/>
          <p:nvPr/>
        </p:nvGrpSpPr>
        <p:grpSpPr>
          <a:xfrm>
            <a:off x="391948" y="551839"/>
            <a:ext cx="7587823" cy="18516064"/>
            <a:chOff x="391948" y="551839"/>
            <a:chExt cx="7587823" cy="18516064"/>
          </a:xfrm>
        </p:grpSpPr>
        <p:sp>
          <p:nvSpPr>
            <p:cNvPr id="2" name="Freeform 2"/>
            <p:cNvSpPr/>
            <p:nvPr/>
          </p:nvSpPr>
          <p:spPr>
            <a:xfrm rot="-5400000">
              <a:off x="-4665348" y="9664739"/>
              <a:ext cx="16934303" cy="1872026"/>
            </a:xfrm>
            <a:custGeom>
              <a:avLst/>
              <a:gdLst/>
              <a:ahLst/>
              <a:cxnLst/>
              <a:rect l="l" t="t" r="r" b="b"/>
              <a:pathLst>
                <a:path w="16934303" h="1872026">
                  <a:moveTo>
                    <a:pt x="0" y="0"/>
                  </a:moveTo>
                  <a:lnTo>
                    <a:pt x="16934302" y="0"/>
                  </a:lnTo>
                  <a:lnTo>
                    <a:pt x="16934302" y="1872026"/>
                  </a:lnTo>
                  <a:lnTo>
                    <a:pt x="0" y="1872026"/>
                  </a:lnTo>
                  <a:lnTo>
                    <a:pt x="0" y="0"/>
                  </a:lnTo>
                  <a:close/>
                </a:path>
              </a:pathLst>
            </a:custGeom>
            <a:blipFill>
              <a:blip r:embed="rId2">
                <a:extLst>
                  <a:ext uri="{96DAC541-7B7A-43D3-8B79-37D633B846F1}">
                    <asvg:svgBlip xmlns:asvg="http://schemas.microsoft.com/office/drawing/2016/SVG/main" r:embed="rId3"/>
                  </a:ext>
                </a:extLst>
              </a:blip>
              <a:stretch>
                <a:fillRect/>
              </a:stretch>
            </a:blipFill>
          </p:spPr>
          <p:txBody>
            <a:bodyPr/>
            <a:lstStyle/>
            <a:p>
              <a:endParaRPr lang="es-MX"/>
            </a:p>
          </p:txBody>
        </p:sp>
        <p:grpSp>
          <p:nvGrpSpPr>
            <p:cNvPr id="3" name="Group 3"/>
            <p:cNvGrpSpPr/>
            <p:nvPr/>
          </p:nvGrpSpPr>
          <p:grpSpPr>
            <a:xfrm>
              <a:off x="2648970" y="1878607"/>
              <a:ext cx="864470" cy="864470"/>
              <a:chOff x="0" y="0"/>
              <a:chExt cx="1152627" cy="1152627"/>
            </a:xfrm>
          </p:grpSpPr>
          <p:grpSp>
            <p:nvGrpSpPr>
              <p:cNvPr id="4" name="Group 4"/>
              <p:cNvGrpSpPr/>
              <p:nvPr/>
            </p:nvGrpSpPr>
            <p:grpSpPr>
              <a:xfrm rot="-5400000">
                <a:off x="0" y="0"/>
                <a:ext cx="1152627" cy="1152627"/>
                <a:chOff x="0" y="0"/>
                <a:chExt cx="812800" cy="812800"/>
              </a:xfrm>
            </p:grpSpPr>
            <p:sp>
              <p:nvSpPr>
                <p:cNvPr id="5" name="Freeform 5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close/>
                    </a:path>
                  </a:pathLst>
                </a:custGeom>
                <a:solidFill>
                  <a:srgbClr val="FFFCFC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6" name="TextBox 6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7" name="Group 7"/>
              <p:cNvGrpSpPr/>
              <p:nvPr/>
            </p:nvGrpSpPr>
            <p:grpSpPr>
              <a:xfrm rot="-5400000">
                <a:off x="128275" y="128275"/>
                <a:ext cx="896077" cy="896077"/>
                <a:chOff x="0" y="0"/>
                <a:chExt cx="812800" cy="812800"/>
              </a:xfrm>
            </p:grpSpPr>
            <p:sp>
              <p:nvSpPr>
                <p:cNvPr id="8" name="Freeform 8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lnTo>
                        <a:pt x="406400" y="0"/>
                      </a:lnTo>
                      <a:close/>
                    </a:path>
                  </a:pathLst>
                </a:custGeom>
                <a:ln w="19050" cap="rnd">
                  <a:solidFill>
                    <a:srgbClr val="969EA4"/>
                  </a:solidFill>
                  <a:prstDash val="sysDot"/>
                  <a:round/>
                </a:ln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9" name="TextBox 9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10" name="Group 10"/>
              <p:cNvGrpSpPr/>
              <p:nvPr/>
            </p:nvGrpSpPr>
            <p:grpSpPr>
              <a:xfrm rot="-5400000">
                <a:off x="234276" y="234276"/>
                <a:ext cx="684075" cy="684075"/>
                <a:chOff x="0" y="0"/>
                <a:chExt cx="108388" cy="108388"/>
              </a:xfrm>
            </p:grpSpPr>
            <p:sp>
              <p:nvSpPr>
                <p:cNvPr id="11" name="Freeform 11"/>
                <p:cNvSpPr/>
                <p:nvPr/>
              </p:nvSpPr>
              <p:spPr>
                <a:xfrm>
                  <a:off x="0" y="0"/>
                  <a:ext cx="108388" cy="108388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388" h="108388">
                      <a:moveTo>
                        <a:pt x="54194" y="0"/>
                      </a:moveTo>
                      <a:cubicBezTo>
                        <a:pt x="24263" y="0"/>
                        <a:pt x="0" y="24263"/>
                        <a:pt x="0" y="54194"/>
                      </a:cubicBezTo>
                      <a:cubicBezTo>
                        <a:pt x="0" y="84124"/>
                        <a:pt x="24263" y="108388"/>
                        <a:pt x="54194" y="108388"/>
                      </a:cubicBezTo>
                      <a:cubicBezTo>
                        <a:pt x="84124" y="108388"/>
                        <a:pt x="108388" y="84124"/>
                        <a:pt x="108388" y="54194"/>
                      </a:cubicBezTo>
                      <a:cubicBezTo>
                        <a:pt x="108388" y="24263"/>
                        <a:pt x="84124" y="0"/>
                        <a:pt x="54194" y="0"/>
                      </a:cubicBezTo>
                      <a:close/>
                    </a:path>
                  </a:pathLst>
                </a:custGeom>
                <a:solidFill>
                  <a:srgbClr val="FFC030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12" name="TextBox 12"/>
                <p:cNvSpPr txBox="1"/>
                <p:nvPr/>
              </p:nvSpPr>
              <p:spPr>
                <a:xfrm>
                  <a:off x="10161" y="-8889"/>
                  <a:ext cx="88065" cy="107115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</p:grpSp>
        <p:grpSp>
          <p:nvGrpSpPr>
            <p:cNvPr id="13" name="Group 13"/>
            <p:cNvGrpSpPr/>
            <p:nvPr/>
          </p:nvGrpSpPr>
          <p:grpSpPr>
            <a:xfrm>
              <a:off x="2648970" y="10144197"/>
              <a:ext cx="864470" cy="864470"/>
              <a:chOff x="0" y="0"/>
              <a:chExt cx="1152627" cy="1152627"/>
            </a:xfrm>
          </p:grpSpPr>
          <p:grpSp>
            <p:nvGrpSpPr>
              <p:cNvPr id="14" name="Group 14"/>
              <p:cNvGrpSpPr/>
              <p:nvPr/>
            </p:nvGrpSpPr>
            <p:grpSpPr>
              <a:xfrm rot="-5400000">
                <a:off x="0" y="0"/>
                <a:ext cx="1152627" cy="1152627"/>
                <a:chOff x="0" y="0"/>
                <a:chExt cx="812800" cy="812800"/>
              </a:xfrm>
            </p:grpSpPr>
            <p:sp>
              <p:nvSpPr>
                <p:cNvPr id="15" name="Freeform 15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close/>
                    </a:path>
                  </a:pathLst>
                </a:custGeom>
                <a:solidFill>
                  <a:srgbClr val="FFFCFC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16" name="TextBox 16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17" name="Group 17"/>
              <p:cNvGrpSpPr/>
              <p:nvPr/>
            </p:nvGrpSpPr>
            <p:grpSpPr>
              <a:xfrm rot="-5400000">
                <a:off x="128275" y="128275"/>
                <a:ext cx="896077" cy="896077"/>
                <a:chOff x="0" y="0"/>
                <a:chExt cx="812800" cy="812800"/>
              </a:xfrm>
            </p:grpSpPr>
            <p:sp>
              <p:nvSpPr>
                <p:cNvPr id="18" name="Freeform 18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lnTo>
                        <a:pt x="406400" y="0"/>
                      </a:lnTo>
                      <a:close/>
                    </a:path>
                  </a:pathLst>
                </a:custGeom>
                <a:ln w="19050" cap="rnd">
                  <a:solidFill>
                    <a:srgbClr val="969EA4"/>
                  </a:solidFill>
                  <a:prstDash val="sysDot"/>
                  <a:round/>
                </a:ln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19" name="TextBox 19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20" name="Group 20"/>
              <p:cNvGrpSpPr/>
              <p:nvPr/>
            </p:nvGrpSpPr>
            <p:grpSpPr>
              <a:xfrm rot="-5400000">
                <a:off x="234276" y="234276"/>
                <a:ext cx="684075" cy="684075"/>
                <a:chOff x="0" y="0"/>
                <a:chExt cx="108388" cy="108388"/>
              </a:xfrm>
            </p:grpSpPr>
            <p:sp>
              <p:nvSpPr>
                <p:cNvPr id="21" name="Freeform 21"/>
                <p:cNvSpPr/>
                <p:nvPr/>
              </p:nvSpPr>
              <p:spPr>
                <a:xfrm>
                  <a:off x="0" y="0"/>
                  <a:ext cx="108388" cy="108388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388" h="108388">
                      <a:moveTo>
                        <a:pt x="54194" y="0"/>
                      </a:moveTo>
                      <a:cubicBezTo>
                        <a:pt x="24263" y="0"/>
                        <a:pt x="0" y="24263"/>
                        <a:pt x="0" y="54194"/>
                      </a:cubicBezTo>
                      <a:cubicBezTo>
                        <a:pt x="0" y="84124"/>
                        <a:pt x="24263" y="108388"/>
                        <a:pt x="54194" y="108388"/>
                      </a:cubicBezTo>
                      <a:cubicBezTo>
                        <a:pt x="84124" y="108388"/>
                        <a:pt x="108388" y="84124"/>
                        <a:pt x="108388" y="54194"/>
                      </a:cubicBezTo>
                      <a:cubicBezTo>
                        <a:pt x="108388" y="24263"/>
                        <a:pt x="84124" y="0"/>
                        <a:pt x="54194" y="0"/>
                      </a:cubicBezTo>
                      <a:close/>
                    </a:path>
                  </a:pathLst>
                </a:custGeom>
                <a:solidFill>
                  <a:srgbClr val="9366E4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22" name="TextBox 22"/>
                <p:cNvSpPr txBox="1"/>
                <p:nvPr/>
              </p:nvSpPr>
              <p:spPr>
                <a:xfrm>
                  <a:off x="10161" y="-8889"/>
                  <a:ext cx="88065" cy="107115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</p:grpSp>
        <p:grpSp>
          <p:nvGrpSpPr>
            <p:cNvPr id="23" name="Group 23"/>
            <p:cNvGrpSpPr/>
            <p:nvPr/>
          </p:nvGrpSpPr>
          <p:grpSpPr>
            <a:xfrm>
              <a:off x="4088227" y="3991425"/>
              <a:ext cx="864470" cy="864470"/>
              <a:chOff x="0" y="0"/>
              <a:chExt cx="1152627" cy="1152627"/>
            </a:xfrm>
          </p:grpSpPr>
          <p:grpSp>
            <p:nvGrpSpPr>
              <p:cNvPr id="24" name="Group 24"/>
              <p:cNvGrpSpPr/>
              <p:nvPr/>
            </p:nvGrpSpPr>
            <p:grpSpPr>
              <a:xfrm rot="-5400000">
                <a:off x="0" y="0"/>
                <a:ext cx="1152627" cy="1152627"/>
                <a:chOff x="0" y="0"/>
                <a:chExt cx="812800" cy="812800"/>
              </a:xfrm>
            </p:grpSpPr>
            <p:sp>
              <p:nvSpPr>
                <p:cNvPr id="25" name="Freeform 25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close/>
                    </a:path>
                  </a:pathLst>
                </a:custGeom>
                <a:solidFill>
                  <a:srgbClr val="FFFCFC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26" name="TextBox 26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27" name="Group 27"/>
              <p:cNvGrpSpPr/>
              <p:nvPr/>
            </p:nvGrpSpPr>
            <p:grpSpPr>
              <a:xfrm rot="-5400000">
                <a:off x="128275" y="128275"/>
                <a:ext cx="896077" cy="896077"/>
                <a:chOff x="0" y="0"/>
                <a:chExt cx="812800" cy="812800"/>
              </a:xfrm>
            </p:grpSpPr>
            <p:sp>
              <p:nvSpPr>
                <p:cNvPr id="28" name="Freeform 28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lnTo>
                        <a:pt x="406400" y="0"/>
                      </a:lnTo>
                      <a:close/>
                    </a:path>
                  </a:pathLst>
                </a:custGeom>
                <a:ln w="19050" cap="rnd">
                  <a:solidFill>
                    <a:srgbClr val="969EA4"/>
                  </a:solidFill>
                  <a:prstDash val="sysDot"/>
                  <a:round/>
                </a:ln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29" name="TextBox 29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30" name="Group 30"/>
              <p:cNvGrpSpPr/>
              <p:nvPr/>
            </p:nvGrpSpPr>
            <p:grpSpPr>
              <a:xfrm rot="-5400000">
                <a:off x="234276" y="234276"/>
                <a:ext cx="684075" cy="684075"/>
                <a:chOff x="0" y="0"/>
                <a:chExt cx="108388" cy="108388"/>
              </a:xfrm>
            </p:grpSpPr>
            <p:sp>
              <p:nvSpPr>
                <p:cNvPr id="31" name="Freeform 31"/>
                <p:cNvSpPr/>
                <p:nvPr/>
              </p:nvSpPr>
              <p:spPr>
                <a:xfrm>
                  <a:off x="0" y="0"/>
                  <a:ext cx="108388" cy="108388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388" h="108388">
                      <a:moveTo>
                        <a:pt x="54194" y="0"/>
                      </a:moveTo>
                      <a:cubicBezTo>
                        <a:pt x="24263" y="0"/>
                        <a:pt x="0" y="24263"/>
                        <a:pt x="0" y="54194"/>
                      </a:cubicBezTo>
                      <a:cubicBezTo>
                        <a:pt x="0" y="84124"/>
                        <a:pt x="24263" y="108388"/>
                        <a:pt x="54194" y="108388"/>
                      </a:cubicBezTo>
                      <a:cubicBezTo>
                        <a:pt x="84124" y="108388"/>
                        <a:pt x="108388" y="84124"/>
                        <a:pt x="108388" y="54194"/>
                      </a:cubicBezTo>
                      <a:cubicBezTo>
                        <a:pt x="108388" y="24263"/>
                        <a:pt x="84124" y="0"/>
                        <a:pt x="54194" y="0"/>
                      </a:cubicBezTo>
                      <a:close/>
                    </a:path>
                  </a:pathLst>
                </a:custGeom>
                <a:solidFill>
                  <a:srgbClr val="FAA64C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32" name="TextBox 32"/>
                <p:cNvSpPr txBox="1"/>
                <p:nvPr/>
              </p:nvSpPr>
              <p:spPr>
                <a:xfrm>
                  <a:off x="10161" y="-8889"/>
                  <a:ext cx="88065" cy="107115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</p:grpSp>
        <p:grpSp>
          <p:nvGrpSpPr>
            <p:cNvPr id="33" name="Group 33"/>
            <p:cNvGrpSpPr/>
            <p:nvPr/>
          </p:nvGrpSpPr>
          <p:grpSpPr>
            <a:xfrm>
              <a:off x="4088227" y="12257015"/>
              <a:ext cx="864470" cy="864470"/>
              <a:chOff x="0" y="0"/>
              <a:chExt cx="1152627" cy="1152627"/>
            </a:xfrm>
          </p:grpSpPr>
          <p:grpSp>
            <p:nvGrpSpPr>
              <p:cNvPr id="34" name="Group 34"/>
              <p:cNvGrpSpPr/>
              <p:nvPr/>
            </p:nvGrpSpPr>
            <p:grpSpPr>
              <a:xfrm rot="-5400000">
                <a:off x="0" y="0"/>
                <a:ext cx="1152627" cy="1152627"/>
                <a:chOff x="0" y="0"/>
                <a:chExt cx="812800" cy="812800"/>
              </a:xfrm>
            </p:grpSpPr>
            <p:sp>
              <p:nvSpPr>
                <p:cNvPr id="35" name="Freeform 35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close/>
                    </a:path>
                  </a:pathLst>
                </a:custGeom>
                <a:solidFill>
                  <a:srgbClr val="FFFCFC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36" name="TextBox 36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37" name="Group 37"/>
              <p:cNvGrpSpPr/>
              <p:nvPr/>
            </p:nvGrpSpPr>
            <p:grpSpPr>
              <a:xfrm rot="-5400000">
                <a:off x="128275" y="128275"/>
                <a:ext cx="896077" cy="896077"/>
                <a:chOff x="0" y="0"/>
                <a:chExt cx="812800" cy="812800"/>
              </a:xfrm>
            </p:grpSpPr>
            <p:sp>
              <p:nvSpPr>
                <p:cNvPr id="38" name="Freeform 38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lnTo>
                        <a:pt x="406400" y="0"/>
                      </a:lnTo>
                      <a:close/>
                    </a:path>
                  </a:pathLst>
                </a:custGeom>
                <a:ln w="19050" cap="rnd">
                  <a:solidFill>
                    <a:srgbClr val="969EA4"/>
                  </a:solidFill>
                  <a:prstDash val="sysDot"/>
                  <a:round/>
                </a:ln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39" name="TextBox 39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40" name="Group 40"/>
              <p:cNvGrpSpPr/>
              <p:nvPr/>
            </p:nvGrpSpPr>
            <p:grpSpPr>
              <a:xfrm rot="-5400000">
                <a:off x="234276" y="234276"/>
                <a:ext cx="684075" cy="684075"/>
                <a:chOff x="0" y="0"/>
                <a:chExt cx="108388" cy="108388"/>
              </a:xfrm>
            </p:grpSpPr>
            <p:sp>
              <p:nvSpPr>
                <p:cNvPr id="41" name="Freeform 41"/>
                <p:cNvSpPr/>
                <p:nvPr/>
              </p:nvSpPr>
              <p:spPr>
                <a:xfrm>
                  <a:off x="0" y="0"/>
                  <a:ext cx="108388" cy="108388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388" h="108388">
                      <a:moveTo>
                        <a:pt x="54194" y="0"/>
                      </a:moveTo>
                      <a:cubicBezTo>
                        <a:pt x="24263" y="0"/>
                        <a:pt x="0" y="24263"/>
                        <a:pt x="0" y="54194"/>
                      </a:cubicBezTo>
                      <a:cubicBezTo>
                        <a:pt x="0" y="84124"/>
                        <a:pt x="24263" y="108388"/>
                        <a:pt x="54194" y="108388"/>
                      </a:cubicBezTo>
                      <a:cubicBezTo>
                        <a:pt x="84124" y="108388"/>
                        <a:pt x="108388" y="84124"/>
                        <a:pt x="108388" y="54194"/>
                      </a:cubicBezTo>
                      <a:cubicBezTo>
                        <a:pt x="108388" y="24263"/>
                        <a:pt x="84124" y="0"/>
                        <a:pt x="54194" y="0"/>
                      </a:cubicBezTo>
                      <a:close/>
                    </a:path>
                  </a:pathLst>
                </a:custGeom>
                <a:solidFill>
                  <a:srgbClr val="5F9FDB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42" name="TextBox 42"/>
                <p:cNvSpPr txBox="1"/>
                <p:nvPr/>
              </p:nvSpPr>
              <p:spPr>
                <a:xfrm>
                  <a:off x="10161" y="-8889"/>
                  <a:ext cx="88065" cy="107115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</p:grpSp>
        <p:grpSp>
          <p:nvGrpSpPr>
            <p:cNvPr id="43" name="Group 43"/>
            <p:cNvGrpSpPr/>
            <p:nvPr/>
          </p:nvGrpSpPr>
          <p:grpSpPr>
            <a:xfrm>
              <a:off x="4088227" y="16445710"/>
              <a:ext cx="864470" cy="864470"/>
              <a:chOff x="0" y="0"/>
              <a:chExt cx="1152627" cy="1152627"/>
            </a:xfrm>
          </p:grpSpPr>
          <p:grpSp>
            <p:nvGrpSpPr>
              <p:cNvPr id="44" name="Group 44"/>
              <p:cNvGrpSpPr/>
              <p:nvPr/>
            </p:nvGrpSpPr>
            <p:grpSpPr>
              <a:xfrm rot="-5400000">
                <a:off x="0" y="0"/>
                <a:ext cx="1152627" cy="1152627"/>
                <a:chOff x="0" y="0"/>
                <a:chExt cx="812800" cy="812800"/>
              </a:xfrm>
            </p:grpSpPr>
            <p:sp>
              <p:nvSpPr>
                <p:cNvPr id="45" name="Freeform 45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close/>
                    </a:path>
                  </a:pathLst>
                </a:custGeom>
                <a:solidFill>
                  <a:srgbClr val="FFFCFC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46" name="TextBox 46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47" name="Group 47"/>
              <p:cNvGrpSpPr/>
              <p:nvPr/>
            </p:nvGrpSpPr>
            <p:grpSpPr>
              <a:xfrm rot="-5400000">
                <a:off x="128275" y="128275"/>
                <a:ext cx="896077" cy="896077"/>
                <a:chOff x="0" y="0"/>
                <a:chExt cx="812800" cy="812800"/>
              </a:xfrm>
            </p:grpSpPr>
            <p:sp>
              <p:nvSpPr>
                <p:cNvPr id="48" name="Freeform 48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lnTo>
                        <a:pt x="406400" y="0"/>
                      </a:lnTo>
                      <a:close/>
                    </a:path>
                  </a:pathLst>
                </a:custGeom>
                <a:ln w="19050" cap="rnd">
                  <a:solidFill>
                    <a:srgbClr val="969EA4"/>
                  </a:solidFill>
                  <a:prstDash val="sysDot"/>
                  <a:round/>
                </a:ln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49" name="TextBox 49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50" name="Group 50"/>
              <p:cNvGrpSpPr/>
              <p:nvPr/>
            </p:nvGrpSpPr>
            <p:grpSpPr>
              <a:xfrm rot="-5400000">
                <a:off x="234276" y="234276"/>
                <a:ext cx="684075" cy="684075"/>
                <a:chOff x="0" y="0"/>
                <a:chExt cx="108388" cy="108388"/>
              </a:xfrm>
            </p:grpSpPr>
            <p:sp>
              <p:nvSpPr>
                <p:cNvPr id="51" name="Freeform 51"/>
                <p:cNvSpPr/>
                <p:nvPr/>
              </p:nvSpPr>
              <p:spPr>
                <a:xfrm>
                  <a:off x="0" y="0"/>
                  <a:ext cx="108388" cy="108388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388" h="108388">
                      <a:moveTo>
                        <a:pt x="54194" y="0"/>
                      </a:moveTo>
                      <a:cubicBezTo>
                        <a:pt x="24263" y="0"/>
                        <a:pt x="0" y="24263"/>
                        <a:pt x="0" y="54194"/>
                      </a:cubicBezTo>
                      <a:cubicBezTo>
                        <a:pt x="0" y="84124"/>
                        <a:pt x="24263" y="108388"/>
                        <a:pt x="54194" y="108388"/>
                      </a:cubicBezTo>
                      <a:cubicBezTo>
                        <a:pt x="84124" y="108388"/>
                        <a:pt x="108388" y="84124"/>
                        <a:pt x="108388" y="54194"/>
                      </a:cubicBezTo>
                      <a:cubicBezTo>
                        <a:pt x="108388" y="24263"/>
                        <a:pt x="84124" y="0"/>
                        <a:pt x="54194" y="0"/>
                      </a:cubicBezTo>
                      <a:close/>
                    </a:path>
                  </a:pathLst>
                </a:custGeom>
                <a:solidFill>
                  <a:srgbClr val="5DC85A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52" name="TextBox 52"/>
                <p:cNvSpPr txBox="1"/>
                <p:nvPr/>
              </p:nvSpPr>
              <p:spPr>
                <a:xfrm>
                  <a:off x="10161" y="-8889"/>
                  <a:ext cx="88065" cy="107115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</p:grpSp>
        <p:grpSp>
          <p:nvGrpSpPr>
            <p:cNvPr id="53" name="Group 53"/>
            <p:cNvGrpSpPr/>
            <p:nvPr/>
          </p:nvGrpSpPr>
          <p:grpSpPr>
            <a:xfrm>
              <a:off x="4088227" y="8182326"/>
              <a:ext cx="864470" cy="864470"/>
              <a:chOff x="0" y="0"/>
              <a:chExt cx="1152627" cy="1152627"/>
            </a:xfrm>
          </p:grpSpPr>
          <p:grpSp>
            <p:nvGrpSpPr>
              <p:cNvPr id="54" name="Group 54"/>
              <p:cNvGrpSpPr/>
              <p:nvPr/>
            </p:nvGrpSpPr>
            <p:grpSpPr>
              <a:xfrm rot="-5400000">
                <a:off x="0" y="0"/>
                <a:ext cx="1152627" cy="1152627"/>
                <a:chOff x="0" y="0"/>
                <a:chExt cx="812800" cy="812800"/>
              </a:xfrm>
            </p:grpSpPr>
            <p:sp>
              <p:nvSpPr>
                <p:cNvPr id="55" name="Freeform 55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close/>
                    </a:path>
                  </a:pathLst>
                </a:custGeom>
                <a:solidFill>
                  <a:srgbClr val="FFFCFC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56" name="TextBox 56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57" name="Group 57"/>
              <p:cNvGrpSpPr/>
              <p:nvPr/>
            </p:nvGrpSpPr>
            <p:grpSpPr>
              <a:xfrm rot="-5400000">
                <a:off x="128275" y="128275"/>
                <a:ext cx="896077" cy="896077"/>
                <a:chOff x="0" y="0"/>
                <a:chExt cx="812800" cy="812800"/>
              </a:xfrm>
            </p:grpSpPr>
            <p:sp>
              <p:nvSpPr>
                <p:cNvPr id="58" name="Freeform 58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lnTo>
                        <a:pt x="406400" y="0"/>
                      </a:lnTo>
                      <a:close/>
                    </a:path>
                  </a:pathLst>
                </a:custGeom>
                <a:ln w="19050" cap="rnd">
                  <a:solidFill>
                    <a:srgbClr val="969EA4"/>
                  </a:solidFill>
                  <a:prstDash val="sysDot"/>
                  <a:round/>
                </a:ln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59" name="TextBox 59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60" name="Group 60"/>
              <p:cNvGrpSpPr/>
              <p:nvPr/>
            </p:nvGrpSpPr>
            <p:grpSpPr>
              <a:xfrm rot="-5400000">
                <a:off x="234276" y="234276"/>
                <a:ext cx="684075" cy="684075"/>
                <a:chOff x="0" y="0"/>
                <a:chExt cx="108388" cy="108388"/>
              </a:xfrm>
            </p:grpSpPr>
            <p:sp>
              <p:nvSpPr>
                <p:cNvPr id="61" name="Freeform 61"/>
                <p:cNvSpPr/>
                <p:nvPr/>
              </p:nvSpPr>
              <p:spPr>
                <a:xfrm>
                  <a:off x="0" y="0"/>
                  <a:ext cx="108388" cy="108388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388" h="108388">
                      <a:moveTo>
                        <a:pt x="54194" y="0"/>
                      </a:moveTo>
                      <a:cubicBezTo>
                        <a:pt x="24263" y="0"/>
                        <a:pt x="0" y="24263"/>
                        <a:pt x="0" y="54194"/>
                      </a:cubicBezTo>
                      <a:cubicBezTo>
                        <a:pt x="0" y="84124"/>
                        <a:pt x="24263" y="108388"/>
                        <a:pt x="54194" y="108388"/>
                      </a:cubicBezTo>
                      <a:cubicBezTo>
                        <a:pt x="84124" y="108388"/>
                        <a:pt x="108388" y="84124"/>
                        <a:pt x="108388" y="54194"/>
                      </a:cubicBezTo>
                      <a:cubicBezTo>
                        <a:pt x="108388" y="24263"/>
                        <a:pt x="84124" y="0"/>
                        <a:pt x="54194" y="0"/>
                      </a:cubicBezTo>
                      <a:close/>
                    </a:path>
                  </a:pathLst>
                </a:custGeom>
                <a:solidFill>
                  <a:srgbClr val="F166BB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62" name="TextBox 62"/>
                <p:cNvSpPr txBox="1"/>
                <p:nvPr/>
              </p:nvSpPr>
              <p:spPr>
                <a:xfrm>
                  <a:off x="10161" y="-8889"/>
                  <a:ext cx="88065" cy="107115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</p:grpSp>
        <p:grpSp>
          <p:nvGrpSpPr>
            <p:cNvPr id="63" name="Group 63"/>
            <p:cNvGrpSpPr/>
            <p:nvPr/>
          </p:nvGrpSpPr>
          <p:grpSpPr>
            <a:xfrm>
              <a:off x="2648970" y="6017652"/>
              <a:ext cx="864470" cy="864470"/>
              <a:chOff x="0" y="0"/>
              <a:chExt cx="1152627" cy="1152627"/>
            </a:xfrm>
          </p:grpSpPr>
          <p:grpSp>
            <p:nvGrpSpPr>
              <p:cNvPr id="64" name="Group 64"/>
              <p:cNvGrpSpPr/>
              <p:nvPr/>
            </p:nvGrpSpPr>
            <p:grpSpPr>
              <a:xfrm rot="-5400000">
                <a:off x="0" y="0"/>
                <a:ext cx="1152627" cy="1152627"/>
                <a:chOff x="0" y="0"/>
                <a:chExt cx="812800" cy="812800"/>
              </a:xfrm>
            </p:grpSpPr>
            <p:sp>
              <p:nvSpPr>
                <p:cNvPr id="65" name="Freeform 65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close/>
                    </a:path>
                  </a:pathLst>
                </a:custGeom>
                <a:solidFill>
                  <a:srgbClr val="FFFCFC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66" name="TextBox 66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67" name="Group 67"/>
              <p:cNvGrpSpPr/>
              <p:nvPr/>
            </p:nvGrpSpPr>
            <p:grpSpPr>
              <a:xfrm rot="-5400000">
                <a:off x="128275" y="128275"/>
                <a:ext cx="896077" cy="896077"/>
                <a:chOff x="0" y="0"/>
                <a:chExt cx="812800" cy="812800"/>
              </a:xfrm>
            </p:grpSpPr>
            <p:sp>
              <p:nvSpPr>
                <p:cNvPr id="68" name="Freeform 68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lnTo>
                        <a:pt x="406400" y="0"/>
                      </a:lnTo>
                      <a:close/>
                    </a:path>
                  </a:pathLst>
                </a:custGeom>
                <a:ln w="19050" cap="rnd">
                  <a:solidFill>
                    <a:srgbClr val="969EA4"/>
                  </a:solidFill>
                  <a:prstDash val="sysDot"/>
                  <a:round/>
                </a:ln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69" name="TextBox 69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70" name="Group 70"/>
              <p:cNvGrpSpPr/>
              <p:nvPr/>
            </p:nvGrpSpPr>
            <p:grpSpPr>
              <a:xfrm rot="-5400000">
                <a:off x="234276" y="234276"/>
                <a:ext cx="684075" cy="684075"/>
                <a:chOff x="0" y="0"/>
                <a:chExt cx="108388" cy="108388"/>
              </a:xfrm>
            </p:grpSpPr>
            <p:sp>
              <p:nvSpPr>
                <p:cNvPr id="71" name="Freeform 71"/>
                <p:cNvSpPr/>
                <p:nvPr/>
              </p:nvSpPr>
              <p:spPr>
                <a:xfrm>
                  <a:off x="0" y="0"/>
                  <a:ext cx="108388" cy="108388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388" h="108388">
                      <a:moveTo>
                        <a:pt x="54194" y="0"/>
                      </a:moveTo>
                      <a:cubicBezTo>
                        <a:pt x="24263" y="0"/>
                        <a:pt x="0" y="24263"/>
                        <a:pt x="0" y="54194"/>
                      </a:cubicBezTo>
                      <a:cubicBezTo>
                        <a:pt x="0" y="84124"/>
                        <a:pt x="24263" y="108388"/>
                        <a:pt x="54194" y="108388"/>
                      </a:cubicBezTo>
                      <a:cubicBezTo>
                        <a:pt x="84124" y="108388"/>
                        <a:pt x="108388" y="84124"/>
                        <a:pt x="108388" y="54194"/>
                      </a:cubicBezTo>
                      <a:cubicBezTo>
                        <a:pt x="108388" y="24263"/>
                        <a:pt x="84124" y="0"/>
                        <a:pt x="54194" y="0"/>
                      </a:cubicBezTo>
                      <a:close/>
                    </a:path>
                  </a:pathLst>
                </a:custGeom>
                <a:solidFill>
                  <a:srgbClr val="DF9078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72" name="TextBox 72"/>
                <p:cNvSpPr txBox="1"/>
                <p:nvPr/>
              </p:nvSpPr>
              <p:spPr>
                <a:xfrm>
                  <a:off x="10161" y="-8889"/>
                  <a:ext cx="88065" cy="107115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</p:grpSp>
        <p:grpSp>
          <p:nvGrpSpPr>
            <p:cNvPr id="73" name="Group 73"/>
            <p:cNvGrpSpPr/>
            <p:nvPr/>
          </p:nvGrpSpPr>
          <p:grpSpPr>
            <a:xfrm>
              <a:off x="2648970" y="14283242"/>
              <a:ext cx="864470" cy="864470"/>
              <a:chOff x="0" y="0"/>
              <a:chExt cx="1152627" cy="1152627"/>
            </a:xfrm>
          </p:grpSpPr>
          <p:grpSp>
            <p:nvGrpSpPr>
              <p:cNvPr id="74" name="Group 74"/>
              <p:cNvGrpSpPr/>
              <p:nvPr/>
            </p:nvGrpSpPr>
            <p:grpSpPr>
              <a:xfrm rot="-5400000">
                <a:off x="0" y="0"/>
                <a:ext cx="1152627" cy="1152627"/>
                <a:chOff x="0" y="0"/>
                <a:chExt cx="812800" cy="812800"/>
              </a:xfrm>
            </p:grpSpPr>
            <p:sp>
              <p:nvSpPr>
                <p:cNvPr id="75" name="Freeform 75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close/>
                    </a:path>
                  </a:pathLst>
                </a:custGeom>
                <a:solidFill>
                  <a:srgbClr val="FFFCFC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76" name="TextBox 76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77" name="Group 77"/>
              <p:cNvGrpSpPr/>
              <p:nvPr/>
            </p:nvGrpSpPr>
            <p:grpSpPr>
              <a:xfrm rot="-5400000">
                <a:off x="128275" y="128275"/>
                <a:ext cx="896077" cy="896077"/>
                <a:chOff x="0" y="0"/>
                <a:chExt cx="812800" cy="812800"/>
              </a:xfrm>
            </p:grpSpPr>
            <p:sp>
              <p:nvSpPr>
                <p:cNvPr id="78" name="Freeform 78"/>
                <p:cNvSpPr/>
                <p:nvPr/>
              </p:nvSpPr>
              <p:spPr>
                <a:xfrm>
                  <a:off x="0" y="0"/>
                  <a:ext cx="812800" cy="812800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812800" h="812800">
                      <a:moveTo>
                        <a:pt x="406400" y="0"/>
                      </a:moveTo>
                      <a:cubicBezTo>
                        <a:pt x="181951" y="0"/>
                        <a:pt x="0" y="181951"/>
                        <a:pt x="0" y="406400"/>
                      </a:cubicBezTo>
                      <a:cubicBezTo>
                        <a:pt x="0" y="630849"/>
                        <a:pt x="181951" y="812800"/>
                        <a:pt x="406400" y="812800"/>
                      </a:cubicBezTo>
                      <a:cubicBezTo>
                        <a:pt x="630849" y="812800"/>
                        <a:pt x="812800" y="630849"/>
                        <a:pt x="812800" y="406400"/>
                      </a:cubicBezTo>
                      <a:cubicBezTo>
                        <a:pt x="812800" y="181951"/>
                        <a:pt x="630849" y="0"/>
                        <a:pt x="406400" y="0"/>
                      </a:cubicBezTo>
                      <a:lnTo>
                        <a:pt x="406400" y="0"/>
                      </a:lnTo>
                      <a:close/>
                    </a:path>
                  </a:pathLst>
                </a:custGeom>
                <a:ln w="19050" cap="rnd">
                  <a:solidFill>
                    <a:srgbClr val="969EA4"/>
                  </a:solidFill>
                  <a:prstDash val="sysDot"/>
                  <a:round/>
                </a:ln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79" name="TextBox 79"/>
                <p:cNvSpPr txBox="1"/>
                <p:nvPr/>
              </p:nvSpPr>
              <p:spPr>
                <a:xfrm>
                  <a:off x="76200" y="57150"/>
                  <a:ext cx="660400" cy="679450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  <p:grpSp>
            <p:nvGrpSpPr>
              <p:cNvPr id="80" name="Group 80"/>
              <p:cNvGrpSpPr/>
              <p:nvPr/>
            </p:nvGrpSpPr>
            <p:grpSpPr>
              <a:xfrm rot="-5400000">
                <a:off x="234276" y="234276"/>
                <a:ext cx="684075" cy="684075"/>
                <a:chOff x="0" y="0"/>
                <a:chExt cx="108388" cy="108388"/>
              </a:xfrm>
            </p:grpSpPr>
            <p:sp>
              <p:nvSpPr>
                <p:cNvPr id="81" name="Freeform 81"/>
                <p:cNvSpPr/>
                <p:nvPr/>
              </p:nvSpPr>
              <p:spPr>
                <a:xfrm>
                  <a:off x="0" y="0"/>
                  <a:ext cx="108388" cy="108388"/>
                </a:xfrm>
                <a:custGeom>
                  <a:avLst/>
                  <a:gdLst/>
                  <a:ahLst/>
                  <a:cxnLst/>
                  <a:rect l="l" t="t" r="r" b="b"/>
                  <a:pathLst>
                    <a:path w="108388" h="108388">
                      <a:moveTo>
                        <a:pt x="54194" y="0"/>
                      </a:moveTo>
                      <a:cubicBezTo>
                        <a:pt x="24263" y="0"/>
                        <a:pt x="0" y="24263"/>
                        <a:pt x="0" y="54194"/>
                      </a:cubicBezTo>
                      <a:cubicBezTo>
                        <a:pt x="0" y="84124"/>
                        <a:pt x="24263" y="108388"/>
                        <a:pt x="54194" y="108388"/>
                      </a:cubicBezTo>
                      <a:cubicBezTo>
                        <a:pt x="84124" y="108388"/>
                        <a:pt x="108388" y="84124"/>
                        <a:pt x="108388" y="54194"/>
                      </a:cubicBezTo>
                      <a:cubicBezTo>
                        <a:pt x="108388" y="24263"/>
                        <a:pt x="84124" y="0"/>
                        <a:pt x="54194" y="0"/>
                      </a:cubicBezTo>
                      <a:close/>
                    </a:path>
                  </a:pathLst>
                </a:custGeom>
                <a:solidFill>
                  <a:srgbClr val="56CDB8"/>
                </a:solidFill>
              </p:spPr>
              <p:txBody>
                <a:bodyPr/>
                <a:lstStyle/>
                <a:p>
                  <a:endParaRPr lang="es-MX"/>
                </a:p>
              </p:txBody>
            </p:sp>
            <p:sp>
              <p:nvSpPr>
                <p:cNvPr id="82" name="TextBox 82"/>
                <p:cNvSpPr txBox="1"/>
                <p:nvPr/>
              </p:nvSpPr>
              <p:spPr>
                <a:xfrm>
                  <a:off x="10161" y="-8889"/>
                  <a:ext cx="88065" cy="107115"/>
                </a:xfrm>
                <a:prstGeom prst="rect">
                  <a:avLst/>
                </a:prstGeom>
              </p:spPr>
              <p:txBody>
                <a:bodyPr lIns="30192" tIns="30192" rIns="30192" bIns="30192" rtlCol="0" anchor="ctr"/>
                <a:lstStyle/>
                <a:p>
                  <a:pPr algn="ctr">
                    <a:lnSpc>
                      <a:spcPts val="1387"/>
                    </a:lnSpc>
                  </a:pPr>
                  <a:endParaRPr/>
                </a:p>
              </p:txBody>
            </p:sp>
          </p:grpSp>
        </p:grpSp>
        <p:sp>
          <p:nvSpPr>
            <p:cNvPr id="83" name="TextBox 83"/>
            <p:cNvSpPr txBox="1"/>
            <p:nvPr/>
          </p:nvSpPr>
          <p:spPr>
            <a:xfrm>
              <a:off x="3876675" y="1618639"/>
              <a:ext cx="3333750" cy="280141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2364"/>
                </a:lnSpc>
                <a:spcBef>
                  <a:spcPct val="0"/>
                </a:spcBef>
              </a:pPr>
              <a:r>
                <a:rPr lang="en-US" sz="1689" b="1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December 19th 2024</a:t>
              </a:r>
            </a:p>
          </p:txBody>
        </p:sp>
        <p:sp>
          <p:nvSpPr>
            <p:cNvPr id="84" name="TextBox 84"/>
            <p:cNvSpPr txBox="1"/>
            <p:nvPr/>
          </p:nvSpPr>
          <p:spPr>
            <a:xfrm>
              <a:off x="3876675" y="5803892"/>
              <a:ext cx="3333750" cy="299997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2364"/>
                </a:lnSpc>
                <a:spcBef>
                  <a:spcPct val="0"/>
                </a:spcBef>
              </a:pPr>
              <a:r>
                <a:rPr lang="en-US" sz="1689" b="1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April 09th 2025</a:t>
              </a:r>
            </a:p>
          </p:txBody>
        </p:sp>
        <p:sp>
          <p:nvSpPr>
            <p:cNvPr id="85" name="TextBox 85"/>
            <p:cNvSpPr txBox="1"/>
            <p:nvPr/>
          </p:nvSpPr>
          <p:spPr>
            <a:xfrm>
              <a:off x="3876675" y="10036510"/>
              <a:ext cx="3333750" cy="299997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2364"/>
                </a:lnSpc>
                <a:spcBef>
                  <a:spcPct val="0"/>
                </a:spcBef>
              </a:pPr>
              <a:r>
                <a:rPr lang="en-US" sz="1689" b="1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April 18th 2025</a:t>
              </a:r>
            </a:p>
          </p:txBody>
        </p:sp>
        <p:sp>
          <p:nvSpPr>
            <p:cNvPr id="86" name="TextBox 86"/>
            <p:cNvSpPr txBox="1"/>
            <p:nvPr/>
          </p:nvSpPr>
          <p:spPr>
            <a:xfrm>
              <a:off x="3978202" y="13834382"/>
              <a:ext cx="3333750" cy="280141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2364"/>
                </a:lnSpc>
                <a:spcBef>
                  <a:spcPct val="0"/>
                </a:spcBef>
              </a:pPr>
              <a:r>
                <a:rPr lang="en-US" sz="1689" b="1" dirty="0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May 13th 2025</a:t>
              </a:r>
            </a:p>
          </p:txBody>
        </p:sp>
        <p:sp>
          <p:nvSpPr>
            <p:cNvPr id="87" name="TextBox 87"/>
            <p:cNvSpPr txBox="1"/>
            <p:nvPr/>
          </p:nvSpPr>
          <p:spPr>
            <a:xfrm>
              <a:off x="391948" y="3768140"/>
              <a:ext cx="3333750" cy="280141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r">
                <a:lnSpc>
                  <a:spcPts val="2364"/>
                </a:lnSpc>
                <a:spcBef>
                  <a:spcPct val="0"/>
                </a:spcBef>
              </a:pPr>
              <a:r>
                <a:rPr lang="en-US" sz="1689" b="1" dirty="0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rPr>
                <a:t>February 2025</a:t>
              </a:r>
            </a:p>
          </p:txBody>
        </p:sp>
        <p:sp>
          <p:nvSpPr>
            <p:cNvPr id="88" name="TextBox 88"/>
            <p:cNvSpPr txBox="1"/>
            <p:nvPr/>
          </p:nvSpPr>
          <p:spPr>
            <a:xfrm>
              <a:off x="391948" y="7988765"/>
              <a:ext cx="3333750" cy="299997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r">
                <a:lnSpc>
                  <a:spcPts val="2364"/>
                </a:lnSpc>
                <a:spcBef>
                  <a:spcPct val="0"/>
                </a:spcBef>
              </a:pPr>
              <a:r>
                <a:rPr lang="en-US" sz="1689" b="1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April 15th 2025 </a:t>
              </a:r>
            </a:p>
          </p:txBody>
        </p:sp>
        <p:sp>
          <p:nvSpPr>
            <p:cNvPr id="89" name="TextBox 89"/>
            <p:cNvSpPr txBox="1"/>
            <p:nvPr/>
          </p:nvSpPr>
          <p:spPr>
            <a:xfrm>
              <a:off x="391948" y="12209390"/>
              <a:ext cx="3333750" cy="299997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r">
                <a:lnSpc>
                  <a:spcPts val="2364"/>
                </a:lnSpc>
                <a:spcBef>
                  <a:spcPct val="0"/>
                </a:spcBef>
              </a:pPr>
              <a:r>
                <a:rPr lang="en-US" sz="1689" b="1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May 10th 2025</a:t>
              </a:r>
            </a:p>
          </p:txBody>
        </p:sp>
        <p:sp>
          <p:nvSpPr>
            <p:cNvPr id="90" name="TextBox 90"/>
            <p:cNvSpPr txBox="1"/>
            <p:nvPr/>
          </p:nvSpPr>
          <p:spPr>
            <a:xfrm>
              <a:off x="3810000" y="2034922"/>
              <a:ext cx="3653903" cy="75642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just">
                <a:lnSpc>
                  <a:spcPts val="1512"/>
                </a:lnSpc>
              </a:pPr>
              <a:r>
                <a:rPr lang="en-US" sz="1200" spc="30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Accidental ingestion of 50% sodium hydroxide,  esophageal burn IIIA according to Zargar’s classification. Stamm gastrostomy placed by endoscopic guidance  (12/20/2024).</a:t>
              </a:r>
            </a:p>
          </p:txBody>
        </p:sp>
        <p:sp>
          <p:nvSpPr>
            <p:cNvPr id="91" name="TextBox 91"/>
            <p:cNvSpPr txBox="1"/>
            <p:nvPr/>
          </p:nvSpPr>
          <p:spPr>
            <a:xfrm>
              <a:off x="3810000" y="6220175"/>
              <a:ext cx="3400425" cy="781431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algn="l">
                <a:lnSpc>
                  <a:spcPts val="1512"/>
                </a:lnSpc>
              </a:pPr>
              <a:r>
                <a:rPr lang="en-US" sz="1200" spc="30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Esophageal dilation. 24 hrs later hemoptysis, fever (39.5C), vomiting, headache, cough and generalized abdominal pain for 4 days.</a:t>
              </a:r>
            </a:p>
            <a:p>
              <a:pPr algn="l">
                <a:lnSpc>
                  <a:spcPts val="1512"/>
                </a:lnSpc>
              </a:pPr>
              <a:r>
                <a:rPr lang="en-US" sz="1200" spc="30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Empirical treatment with paracetamol.</a:t>
              </a:r>
            </a:p>
          </p:txBody>
        </p:sp>
        <p:sp>
          <p:nvSpPr>
            <p:cNvPr id="92" name="TextBox 92"/>
            <p:cNvSpPr txBox="1"/>
            <p:nvPr/>
          </p:nvSpPr>
          <p:spPr>
            <a:xfrm>
              <a:off x="3810000" y="10462318"/>
              <a:ext cx="3333750" cy="105668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673"/>
                </a:lnSpc>
              </a:pPr>
              <a:r>
                <a:rPr lang="en-US" sz="1327" spc="33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Admision to ICU for 4 days due to somnolence, bradicardia, hipoNatremia. CPR 5.4 mg/dl. During hospitalization persistent irritability, headache and somnolence. Discharge May 1st. </a:t>
              </a:r>
            </a:p>
          </p:txBody>
        </p:sp>
        <p:sp>
          <p:nvSpPr>
            <p:cNvPr id="93" name="TextBox 93"/>
            <p:cNvSpPr txBox="1"/>
            <p:nvPr/>
          </p:nvSpPr>
          <p:spPr>
            <a:xfrm>
              <a:off x="4366282" y="17884910"/>
              <a:ext cx="2844143" cy="85626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673"/>
                </a:lnSpc>
              </a:pPr>
              <a:r>
                <a:rPr lang="en-US" sz="1327" spc="33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Complete targeted antimicrobial therapy for 35 days. Sequels right hemibody hemiparesis. Continues with periodic esophageal dilations.  </a:t>
              </a:r>
            </a:p>
          </p:txBody>
        </p:sp>
        <p:sp>
          <p:nvSpPr>
            <p:cNvPr id="94" name="TextBox 94"/>
            <p:cNvSpPr txBox="1"/>
            <p:nvPr/>
          </p:nvSpPr>
          <p:spPr>
            <a:xfrm>
              <a:off x="1358879" y="4159278"/>
              <a:ext cx="2548084" cy="84638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r">
                <a:lnSpc>
                  <a:spcPts val="1673"/>
                </a:lnSpc>
              </a:pPr>
              <a:r>
                <a:rPr lang="en-US" sz="1327" spc="33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Treatment was initiated with esophageal dilations once a week</a:t>
              </a:r>
            </a:p>
            <a:p>
              <a:pPr algn="r">
                <a:lnSpc>
                  <a:spcPts val="1512"/>
                </a:lnSpc>
              </a:pPr>
              <a:endParaRPr lang="en-US" sz="1327" spc="33" dirty="0">
                <a:solidFill>
                  <a:srgbClr val="545454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5" name="TextBox 95"/>
            <p:cNvSpPr txBox="1"/>
            <p:nvPr/>
          </p:nvSpPr>
          <p:spPr>
            <a:xfrm>
              <a:off x="459857" y="8330217"/>
              <a:ext cx="3333750" cy="114114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just">
                <a:lnSpc>
                  <a:spcPts val="1512"/>
                </a:lnSpc>
              </a:pPr>
              <a:r>
                <a:rPr lang="en-US" sz="1200" spc="30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Admitted for persisting nausea and vomiting . Twenty-four hrs latter somnolence, hematemesis ,Na 123 mEq/lt, drop of 2 gr of Hb. Esophagogram ruled out esophageal perforation.. Conservative treatment with clinical improvement.</a:t>
              </a:r>
            </a:p>
          </p:txBody>
        </p:sp>
        <p:sp>
          <p:nvSpPr>
            <p:cNvPr id="96" name="TextBox 96"/>
            <p:cNvSpPr txBox="1"/>
            <p:nvPr/>
          </p:nvSpPr>
          <p:spPr>
            <a:xfrm>
              <a:off x="467084" y="12616148"/>
              <a:ext cx="3333750" cy="420243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r">
                <a:lnSpc>
                  <a:spcPts val="1673"/>
                </a:lnSpc>
              </a:pPr>
              <a:r>
                <a:rPr lang="en-US" sz="1327" spc="33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Acute right sided spasticity,</a:t>
              </a:r>
            </a:p>
            <a:p>
              <a:pPr algn="r">
                <a:lnSpc>
                  <a:spcPts val="1673"/>
                </a:lnSpc>
              </a:pPr>
              <a:r>
                <a:rPr lang="en-US" sz="1327" spc="33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 paresthesia and hemiparesis.</a:t>
              </a:r>
            </a:p>
          </p:txBody>
        </p:sp>
        <p:sp>
          <p:nvSpPr>
            <p:cNvPr id="97" name="TextBox 97"/>
            <p:cNvSpPr txBox="1"/>
            <p:nvPr/>
          </p:nvSpPr>
          <p:spPr>
            <a:xfrm>
              <a:off x="391948" y="16280016"/>
              <a:ext cx="3333750" cy="299997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r">
                <a:lnSpc>
                  <a:spcPts val="2364"/>
                </a:lnSpc>
                <a:spcBef>
                  <a:spcPct val="0"/>
                </a:spcBef>
              </a:pPr>
              <a:r>
                <a:rPr lang="en-US" sz="1689" b="1" dirty="0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May 14th 2025</a:t>
              </a:r>
            </a:p>
          </p:txBody>
        </p:sp>
        <p:sp>
          <p:nvSpPr>
            <p:cNvPr id="98" name="TextBox 98"/>
            <p:cNvSpPr txBox="1"/>
            <p:nvPr/>
          </p:nvSpPr>
          <p:spPr>
            <a:xfrm>
              <a:off x="573213" y="16613835"/>
              <a:ext cx="3333750" cy="1074268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r">
                <a:lnSpc>
                  <a:spcPts val="1673"/>
                </a:lnSpc>
              </a:pPr>
              <a:r>
                <a:rPr lang="en-US" sz="1327" spc="33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On admission GCS 11, CRP 6.53 mg/L and PCT 1.9 ng/ ml. PO of left Precoronal trepanectomy, yielding 1700 cc. of purulent material positive for Streptococcus intermedius. </a:t>
              </a:r>
            </a:p>
          </p:txBody>
        </p:sp>
        <p:sp>
          <p:nvSpPr>
            <p:cNvPr id="99" name="TextBox 99"/>
            <p:cNvSpPr txBox="1"/>
            <p:nvPr/>
          </p:nvSpPr>
          <p:spPr>
            <a:xfrm>
              <a:off x="762000" y="551839"/>
              <a:ext cx="6096000" cy="742950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0" lvl="0" indent="0" algn="ctr">
                <a:lnSpc>
                  <a:spcPts val="5769"/>
                </a:lnSpc>
                <a:spcBef>
                  <a:spcPct val="0"/>
                </a:spcBef>
              </a:pPr>
              <a:r>
                <a:rPr lang="en-US" sz="4808" b="1" dirty="0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Timeline frame</a:t>
              </a:r>
            </a:p>
          </p:txBody>
        </p:sp>
        <p:sp>
          <p:nvSpPr>
            <p:cNvPr id="100" name="TextBox 100"/>
            <p:cNvSpPr txBox="1"/>
            <p:nvPr/>
          </p:nvSpPr>
          <p:spPr>
            <a:xfrm>
              <a:off x="4646021" y="17533822"/>
              <a:ext cx="3333750" cy="299997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2364"/>
                </a:lnSpc>
                <a:spcBef>
                  <a:spcPct val="0"/>
                </a:spcBef>
              </a:pPr>
              <a:r>
                <a:rPr lang="en-US" sz="1689" b="1" dirty="0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June  19 </a:t>
              </a:r>
              <a:r>
                <a:rPr lang="en-US" sz="1689" b="1" dirty="0" err="1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th</a:t>
              </a:r>
              <a:r>
                <a:rPr lang="en-US" sz="1689" b="1" dirty="0">
                  <a:solidFill>
                    <a:srgbClr val="000000"/>
                  </a:solidFill>
                  <a:latin typeface="Arial Bold"/>
                  <a:ea typeface="Arial Bold"/>
                  <a:cs typeface="Arial Bold"/>
                  <a:sym typeface="Arial Bold"/>
                </a:rPr>
                <a:t> 2025</a:t>
              </a:r>
            </a:p>
          </p:txBody>
        </p:sp>
        <p:sp>
          <p:nvSpPr>
            <p:cNvPr id="101" name="TextBox 101"/>
            <p:cNvSpPr txBox="1"/>
            <p:nvPr/>
          </p:nvSpPr>
          <p:spPr>
            <a:xfrm>
              <a:off x="3970076" y="14212696"/>
              <a:ext cx="3333750" cy="1510285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algn="l">
                <a:lnSpc>
                  <a:spcPts val="1673"/>
                </a:lnSpc>
              </a:pPr>
              <a:r>
                <a:rPr lang="en-US" sz="1327" spc="33" dirty="0">
                  <a:solidFill>
                    <a:srgbClr val="545454"/>
                  </a:solidFill>
                  <a:latin typeface="Arial"/>
                  <a:ea typeface="Arial"/>
                  <a:cs typeface="Arial"/>
                  <a:sym typeface="Arial"/>
                </a:rPr>
                <a:t>Admitted due to GCS of 12, somnolence, aphasia and inability to sit. CT scan revealed frontotemporal cerebral abscess, edema, midline deviation. PCT 1.9 ng/ml CRP 6.54 mg/L  Empiric antimicrobial and antiepileptic treatment. Transferred to other institution for surgical treatment..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280</Words>
  <Application>Microsoft Office PowerPoint</Application>
  <PresentationFormat>Personalizado</PresentationFormat>
  <Paragraphs>2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Calibri</vt:lpstr>
      <vt:lpstr>Arial</vt:lpstr>
      <vt:lpstr>Arial Bold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ografía Línea de Tiempo Timeline Fechas Moderno Infográfico Multicolor</dc:title>
  <dc:creator>Ana Alejandra</dc:creator>
  <cp:lastModifiedBy>Anna Alejandra Ortiz</cp:lastModifiedBy>
  <cp:revision>5</cp:revision>
  <dcterms:created xsi:type="dcterms:W3CDTF">2006-08-16T00:00:00Z</dcterms:created>
  <dcterms:modified xsi:type="dcterms:W3CDTF">2026-02-06T20:17:40Z</dcterms:modified>
  <dc:identifier>DAG7JEz0-0k</dc:identifier>
</cp:coreProperties>
</file>